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handoutMasterIdLst>
    <p:handoutMasterId r:id="rId6"/>
  </p:handoutMasterIdLst>
  <p:sldIdLst>
    <p:sldId id="258" r:id="rId2"/>
    <p:sldId id="260" r:id="rId3"/>
    <p:sldId id="266" r:id="rId4"/>
  </p:sldIdLst>
  <p:sldSz cx="7772400" cy="10058400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olino, Alexander" initials="PA" lastIdx="3" clrIdx="0">
    <p:extLst>
      <p:ext uri="{19B8F6BF-5375-455C-9EA6-DF929625EA0E}">
        <p15:presenceInfo xmlns:p15="http://schemas.microsoft.com/office/powerpoint/2012/main" userId="Polino, Alexand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8AA7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89942" autoAdjust="0"/>
  </p:normalViewPr>
  <p:slideViewPr>
    <p:cSldViewPr snapToGrid="0">
      <p:cViewPr varScale="1">
        <p:scale>
          <a:sx n="55" d="100"/>
          <a:sy n="55" d="100"/>
        </p:scale>
        <p:origin x="218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56550" y="0"/>
            <a:ext cx="3026833" cy="465797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01223E73-4FD7-4C9B-AA31-73C18806E29E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17904"/>
            <a:ext cx="3026833" cy="465796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56550" y="8817904"/>
            <a:ext cx="3026833" cy="465796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D507AFCE-AE11-47E9-8E40-15EB69A96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49608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0"/>
            <a:ext cx="3026833" cy="465797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E52CDB2D-B92D-43F6-8933-F94D5CC0D8DE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1238" y="1160463"/>
            <a:ext cx="2422525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1"/>
            <a:ext cx="5588000" cy="3655457"/>
          </a:xfrm>
          <a:prstGeom prst="rect">
            <a:avLst/>
          </a:prstGeom>
        </p:spPr>
        <p:txBody>
          <a:bodyPr vert="horz" lIns="92958" tIns="46479" rIns="92958" bIns="4647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5796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5796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E8901996-7B97-4402-AA3A-9D1CDBDB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746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 A/B</a:t>
            </a:r>
            <a:r>
              <a:rPr lang="en-US" baseline="0" dirty="0"/>
              <a:t> – ACT2H</a:t>
            </a:r>
          </a:p>
          <a:p>
            <a:r>
              <a:rPr lang="en-US" baseline="0" dirty="0"/>
              <a:t>C/D – ACT2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901996-7B97-4402-AA3A-9D1CDBDBE88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8412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901996-7B97-4402-AA3A-9D1CDBDBE88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9645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901996-7B97-4402-AA3A-9D1CDBDBE88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7772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5083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6208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2173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4782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495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5452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7819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4511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0036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0207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7606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33CF04-58DE-46DF-9A85-E69E6A8AACAB}" type="datetimeFigureOut">
              <a:rPr lang="en-US" smtClean="0"/>
              <a:t>7/15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BD3CF-31B1-4CEE-B09F-0D9CF0BE7E6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488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3.tiff"/><Relationship Id="rId7" Type="http://schemas.openxmlformats.org/officeDocument/2006/relationships/image" Target="../media/image6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10.tiff"/><Relationship Id="rId5" Type="http://schemas.openxmlformats.org/officeDocument/2006/relationships/image" Target="../media/image5.png"/><Relationship Id="rId10" Type="http://schemas.openxmlformats.org/officeDocument/2006/relationships/image" Target="../media/image9.tiff"/><Relationship Id="rId4" Type="http://schemas.openxmlformats.org/officeDocument/2006/relationships/image" Target="../media/image4.tiff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13" Type="http://schemas.openxmlformats.org/officeDocument/2006/relationships/image" Target="../media/image17.tiff"/><Relationship Id="rId3" Type="http://schemas.openxmlformats.org/officeDocument/2006/relationships/image" Target="../media/image11.png"/><Relationship Id="rId7" Type="http://schemas.openxmlformats.org/officeDocument/2006/relationships/image" Target="../media/image13.png"/><Relationship Id="rId12" Type="http://schemas.openxmlformats.org/officeDocument/2006/relationships/image" Target="../media/image16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microsoft.com/office/2007/relationships/hdphoto" Target="../media/hdphoto3.wdp"/><Relationship Id="rId11" Type="http://schemas.microsoft.com/office/2007/relationships/hdphoto" Target="../media/hdphoto5.wdp"/><Relationship Id="rId5" Type="http://schemas.openxmlformats.org/officeDocument/2006/relationships/image" Target="../media/image12.png"/><Relationship Id="rId15" Type="http://schemas.microsoft.com/office/2007/relationships/hdphoto" Target="../media/hdphoto6.wdp"/><Relationship Id="rId10" Type="http://schemas.openxmlformats.org/officeDocument/2006/relationships/image" Target="../media/image15.png"/><Relationship Id="rId4" Type="http://schemas.microsoft.com/office/2007/relationships/hdphoto" Target="../media/hdphoto2.wdp"/><Relationship Id="rId9" Type="http://schemas.openxmlformats.org/officeDocument/2006/relationships/image" Target="../media/image14.tiff"/><Relationship Id="rId1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54451DF9-DEBA-25F2-FEC3-988454A7C225}"/>
              </a:ext>
            </a:extLst>
          </p:cNvPr>
          <p:cNvSpPr txBox="1"/>
          <p:nvPr/>
        </p:nvSpPr>
        <p:spPr>
          <a:xfrm>
            <a:off x="79692" y="3954451"/>
            <a:ext cx="7538819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. Stimulating MIN6 cells does not substantially change ratio F-:G-act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– MIN6 cells were stimulated with low glucose (1 mM), high glucose (20 mM), or high glucose plus 30 mM KCl for 5 minutes, then actin filaments separated by ultracentrifugation – filaments fall to the pellet (“Pel.”) whil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unfilamente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ctin remains in the supernatant (“Sup.”) – and assessed by western blot. 30 minutes treatments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atrunculi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B (depolymerizes filaments)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jasplakinolid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polymerizes filaments) serve as controls. Experiment was performed four times. A representative experiment is shown (left), while all experiments are quantified at right. Bars represent standard deviation of the measurements.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5711491"/>
              </p:ext>
            </p:extLst>
          </p:nvPr>
        </p:nvGraphicFramePr>
        <p:xfrm>
          <a:off x="5624611" y="413251"/>
          <a:ext cx="1993900" cy="3751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1994071" imgH="3750644" progId="Prism9.Document">
                  <p:embed/>
                </p:oleObj>
              </mc:Choice>
              <mc:Fallback>
                <p:oleObj name="Prism 9" r:id="rId3" imgW="1994071" imgH="375064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624611" y="413251"/>
                        <a:ext cx="1993900" cy="3751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oup 5"/>
          <p:cNvGrpSpPr/>
          <p:nvPr/>
        </p:nvGrpSpPr>
        <p:grpSpPr>
          <a:xfrm>
            <a:off x="180899" y="1216625"/>
            <a:ext cx="5324088" cy="1511545"/>
            <a:chOff x="3931264" y="2992416"/>
            <a:chExt cx="5324088" cy="1511545"/>
          </a:xfrm>
        </p:grpSpPr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5EEE824E-993C-972D-D252-040D482B83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41221" b="44697"/>
            <a:stretch/>
          </p:blipFill>
          <p:spPr>
            <a:xfrm>
              <a:off x="4075476" y="3588342"/>
              <a:ext cx="5140384" cy="692109"/>
            </a:xfrm>
            <a:prstGeom prst="rect">
              <a:avLst/>
            </a:prstGeom>
          </p:spPr>
        </p:pic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20C9028C-1C27-6868-19AD-F38F9A87181E}"/>
                </a:ext>
              </a:extLst>
            </p:cNvPr>
            <p:cNvSpPr txBox="1"/>
            <p:nvPr/>
          </p:nvSpPr>
          <p:spPr>
            <a:xfrm>
              <a:off x="4781120" y="3161693"/>
              <a:ext cx="94288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2.8mM Gluc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Pel.   Sup.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2ABC0BFD-13D1-93B0-181C-F76F8D8551C5}"/>
                </a:ext>
              </a:extLst>
            </p:cNvPr>
            <p:cNvSpPr txBox="1"/>
            <p:nvPr/>
          </p:nvSpPr>
          <p:spPr>
            <a:xfrm>
              <a:off x="5580516" y="3161693"/>
              <a:ext cx="904415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20mM Gluc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Pel.   Sup.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25F100B-E218-B2E7-5EDB-5AF449FF8EAE}"/>
                </a:ext>
              </a:extLst>
            </p:cNvPr>
            <p:cNvSpPr txBox="1"/>
            <p:nvPr/>
          </p:nvSpPr>
          <p:spPr>
            <a:xfrm>
              <a:off x="6420284" y="2992416"/>
              <a:ext cx="925253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mM Gluc</a:t>
              </a:r>
            </a:p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+30mM KCl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Pel.   Sup.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F6E8FBD9-5D92-65A9-1F25-558712C7CB1C}"/>
                </a:ext>
              </a:extLst>
            </p:cNvPr>
            <p:cNvSpPr txBox="1"/>
            <p:nvPr/>
          </p:nvSpPr>
          <p:spPr>
            <a:xfrm>
              <a:off x="7336012" y="2992416"/>
              <a:ext cx="872355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1uM LatB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Pel.   Sup.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CD24046E-9675-E345-5E14-B5E6A94D97C4}"/>
                </a:ext>
              </a:extLst>
            </p:cNvPr>
            <p:cNvSpPr txBox="1"/>
            <p:nvPr/>
          </p:nvSpPr>
          <p:spPr>
            <a:xfrm>
              <a:off x="8213640" y="2992416"/>
              <a:ext cx="872355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1uM Jasp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Pel.   Sup.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DD0D11A-336F-4F3D-01BE-AB89BD2CA003}"/>
                </a:ext>
              </a:extLst>
            </p:cNvPr>
            <p:cNvSpPr txBox="1"/>
            <p:nvPr/>
          </p:nvSpPr>
          <p:spPr>
            <a:xfrm>
              <a:off x="3931264" y="3604818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 kDa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6670B50E-DDBA-6101-CB0C-2C6C17D841BC}"/>
                </a:ext>
              </a:extLst>
            </p:cNvPr>
            <p:cNvSpPr txBox="1"/>
            <p:nvPr/>
          </p:nvSpPr>
          <p:spPr>
            <a:xfrm>
              <a:off x="3931264" y="3980741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 kDa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DD0D11A-336F-4F3D-01BE-AB89BD2CA003}"/>
                </a:ext>
              </a:extLst>
            </p:cNvPr>
            <p:cNvSpPr txBox="1"/>
            <p:nvPr/>
          </p:nvSpPr>
          <p:spPr>
            <a:xfrm>
              <a:off x="8399027" y="4242351"/>
              <a:ext cx="8563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l-GR" sz="1100" dirty="0"/>
                <a:t>β</a:t>
              </a:r>
              <a:r>
                <a:rPr lang="en-US" sz="1100" dirty="0"/>
                <a:t>-act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17415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868069" y="440835"/>
            <a:ext cx="5559922" cy="4603508"/>
            <a:chOff x="695790" y="109531"/>
            <a:chExt cx="5559922" cy="460350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93" t="-38" r="184" b="-138"/>
            <a:stretch/>
          </p:blipFill>
          <p:spPr>
            <a:xfrm>
              <a:off x="3512512" y="109531"/>
              <a:ext cx="2743200" cy="205885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67" t="-44" r="159" b="-132"/>
            <a:stretch/>
          </p:blipFill>
          <p:spPr>
            <a:xfrm>
              <a:off x="695790" y="2408619"/>
              <a:ext cx="2743200" cy="205885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08" t="150" r="313" b="-236"/>
            <a:stretch/>
          </p:blipFill>
          <p:spPr>
            <a:xfrm>
              <a:off x="3512512" y="2408619"/>
              <a:ext cx="2743200" cy="2061328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5790" y="109531"/>
              <a:ext cx="2743200" cy="205740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662471" y="2115327"/>
              <a:ext cx="8098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Overview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256376" y="2115327"/>
              <a:ext cx="12554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2.8 mM Glucose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458889" y="4451429"/>
              <a:ext cx="12170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20 mM Glucose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873691" y="4451429"/>
              <a:ext cx="20954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20 mM Glucose + 30 mM KCl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868069" y="5178021"/>
            <a:ext cx="5559922" cy="4589644"/>
            <a:chOff x="695790" y="5119431"/>
            <a:chExt cx="5559922" cy="4589644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" t="-56" r="-74" b="249"/>
            <a:stretch/>
          </p:blipFill>
          <p:spPr>
            <a:xfrm>
              <a:off x="3512512" y="5119431"/>
              <a:ext cx="2743200" cy="205339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5790" y="7422149"/>
              <a:ext cx="2743200" cy="205740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12512" y="7422149"/>
              <a:ext cx="2743200" cy="20574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5790" y="5119431"/>
              <a:ext cx="2743200" cy="205740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1570322" y="7127405"/>
              <a:ext cx="8098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Overview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164227" y="7127405"/>
              <a:ext cx="12554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2.8 mM Glucose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366740" y="9447465"/>
              <a:ext cx="12170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20 mM Glucose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781542" y="9447465"/>
              <a:ext cx="20954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20 mM Glucose + 30 mM KCl</a:t>
              </a:r>
            </a:p>
          </p:txBody>
        </p:sp>
      </p:grpSp>
      <p:sp>
        <p:nvSpPr>
          <p:cNvPr id="9" name="TextBox 8"/>
          <p:cNvSpPr txBox="1"/>
          <p:nvPr/>
        </p:nvSpPr>
        <p:spPr>
          <a:xfrm rot="16200000">
            <a:off x="69045" y="2408159"/>
            <a:ext cx="6751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IN6</a:t>
            </a:r>
          </a:p>
        </p:txBody>
      </p:sp>
      <p:sp>
        <p:nvSpPr>
          <p:cNvPr id="26" name="Title 1">
            <a:extLst>
              <a:ext uri="{FF2B5EF4-FFF2-40B4-BE49-F238E27FC236}">
                <a16:creationId xmlns:a16="http://schemas.microsoft.com/office/drawing/2014/main" id="{39526920-AD95-4C40-ABFB-4D05D09F77AE}"/>
              </a:ext>
            </a:extLst>
          </p:cNvPr>
          <p:cNvSpPr txBox="1">
            <a:spLocks/>
          </p:cNvSpPr>
          <p:nvPr/>
        </p:nvSpPr>
        <p:spPr>
          <a:xfrm>
            <a:off x="46258" y="203102"/>
            <a:ext cx="7572253" cy="18266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5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800" dirty="0"/>
              <a:t>Figure S2: Zoomed out photos from Fig. 2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549737" y="627451"/>
            <a:ext cx="0" cy="39545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 rot="16200000">
            <a:off x="-255562" y="7066915"/>
            <a:ext cx="1324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ouse islets</a:t>
            </a:r>
          </a:p>
        </p:txBody>
      </p:sp>
      <p:cxnSp>
        <p:nvCxnSpPr>
          <p:cNvPr id="28" name="Straight Connector 27"/>
          <p:cNvCxnSpPr/>
          <p:nvPr/>
        </p:nvCxnSpPr>
        <p:spPr>
          <a:xfrm>
            <a:off x="549737" y="5286207"/>
            <a:ext cx="0" cy="39545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052236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6D8F2FD9-4F12-5571-C304-EAE22F179FA4}"/>
              </a:ext>
            </a:extLst>
          </p:cNvPr>
          <p:cNvSpPr txBox="1"/>
          <p:nvPr/>
        </p:nvSpPr>
        <p:spPr>
          <a:xfrm>
            <a:off x="348925" y="63768"/>
            <a:ext cx="429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4451DF9-DEBA-25F2-FEC3-988454A7C225}"/>
              </a:ext>
            </a:extLst>
          </p:cNvPr>
          <p:cNvSpPr txBox="1"/>
          <p:nvPr/>
        </p:nvSpPr>
        <p:spPr>
          <a:xfrm>
            <a:off x="45069" y="9583084"/>
            <a:ext cx="753881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More and uncropped photos from Fig. 5 –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) Uncropped photos from Fig. 5A, (B) An additional view from each samples at 5,000x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15817EB-4067-7357-4F2B-EDA83DED9F4F}"/>
              </a:ext>
            </a:extLst>
          </p:cNvPr>
          <p:cNvSpPr txBox="1"/>
          <p:nvPr/>
        </p:nvSpPr>
        <p:spPr>
          <a:xfrm rot="16200000">
            <a:off x="142028" y="1249682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o dru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F6CEA5-429B-52CC-9CB1-906E7D39E3A1}"/>
              </a:ext>
            </a:extLst>
          </p:cNvPr>
          <p:cNvSpPr txBox="1"/>
          <p:nvPr/>
        </p:nvSpPr>
        <p:spPr>
          <a:xfrm rot="5400000">
            <a:off x="6456800" y="1117744"/>
            <a:ext cx="6014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yto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F6C99E-233A-CA8B-45D7-1BDDCC1944FE}"/>
              </a:ext>
            </a:extLst>
          </p:cNvPr>
          <p:cNvSpPr txBox="1"/>
          <p:nvPr/>
        </p:nvSpPr>
        <p:spPr>
          <a:xfrm rot="16200000">
            <a:off x="277221" y="3566215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at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89C2B5A-95F6-3D8A-9454-FF24F4BAA10F}"/>
              </a:ext>
            </a:extLst>
          </p:cNvPr>
          <p:cNvSpPr txBox="1"/>
          <p:nvPr/>
        </p:nvSpPr>
        <p:spPr>
          <a:xfrm rot="5400000">
            <a:off x="6573819" y="3566216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Jasp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9" t="-368" r="-102" b="189"/>
          <a:stretch/>
        </p:blipFill>
        <p:spPr>
          <a:xfrm>
            <a:off x="689863" y="4985498"/>
            <a:ext cx="2919461" cy="219456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68" t="475" r="241" b="-268"/>
          <a:stretch/>
        </p:blipFill>
        <p:spPr>
          <a:xfrm>
            <a:off x="3712832" y="4988509"/>
            <a:ext cx="2932732" cy="219456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565" r="198" b="315"/>
          <a:stretch/>
        </p:blipFill>
        <p:spPr>
          <a:xfrm>
            <a:off x="696442" y="7218524"/>
            <a:ext cx="2912882" cy="219456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2" t="114" r="215" b="24"/>
          <a:stretch/>
        </p:blipFill>
        <p:spPr>
          <a:xfrm>
            <a:off x="3712832" y="7229954"/>
            <a:ext cx="2924890" cy="219456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15817EB-4067-7357-4F2B-EDA83DED9F4F}"/>
              </a:ext>
            </a:extLst>
          </p:cNvPr>
          <p:cNvSpPr txBox="1"/>
          <p:nvPr/>
        </p:nvSpPr>
        <p:spPr>
          <a:xfrm rot="16200000">
            <a:off x="202536" y="5938287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o drug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1F6CEA5-429B-52CC-9CB1-906E7D39E3A1}"/>
              </a:ext>
            </a:extLst>
          </p:cNvPr>
          <p:cNvSpPr txBox="1"/>
          <p:nvPr/>
        </p:nvSpPr>
        <p:spPr>
          <a:xfrm rot="5400000">
            <a:off x="6478456" y="5975470"/>
            <a:ext cx="6014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yto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AF6C99E-233A-CA8B-45D7-1BDDCC1944FE}"/>
              </a:ext>
            </a:extLst>
          </p:cNvPr>
          <p:cNvSpPr txBox="1"/>
          <p:nvPr/>
        </p:nvSpPr>
        <p:spPr>
          <a:xfrm rot="16200000">
            <a:off x="321992" y="8325478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at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89C2B5A-95F6-3D8A-9454-FF24F4BAA10F}"/>
              </a:ext>
            </a:extLst>
          </p:cNvPr>
          <p:cNvSpPr txBox="1"/>
          <p:nvPr/>
        </p:nvSpPr>
        <p:spPr>
          <a:xfrm rot="5400000">
            <a:off x="6525744" y="8241411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Jas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D8F2FD9-4F12-5571-C304-EAE22F179FA4}"/>
              </a:ext>
            </a:extLst>
          </p:cNvPr>
          <p:cNvSpPr txBox="1"/>
          <p:nvPr/>
        </p:nvSpPr>
        <p:spPr>
          <a:xfrm>
            <a:off x="277058" y="4921588"/>
            <a:ext cx="429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 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2" t="205" r="186" b="645"/>
          <a:stretch/>
        </p:blipFill>
        <p:spPr>
          <a:xfrm>
            <a:off x="666897" y="359840"/>
            <a:ext cx="2942427" cy="219456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" t="275" r="570" b="-86"/>
          <a:stretch/>
        </p:blipFill>
        <p:spPr>
          <a:xfrm>
            <a:off x="3699184" y="359840"/>
            <a:ext cx="2913887" cy="219456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04" t="-532" r="-20" b="842"/>
          <a:stretch/>
        </p:blipFill>
        <p:spPr>
          <a:xfrm>
            <a:off x="658860" y="2577366"/>
            <a:ext cx="2950464" cy="219456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89" t="-194" r="-450" b="1494"/>
          <a:stretch/>
        </p:blipFill>
        <p:spPr>
          <a:xfrm>
            <a:off x="3699184" y="2578643"/>
            <a:ext cx="2983617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4830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73</TotalTime>
  <Words>273</Words>
  <Application>Microsoft Office PowerPoint</Application>
  <PresentationFormat>Custom</PresentationFormat>
  <Paragraphs>44</Paragraphs>
  <Slides>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Company>WUS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tin filament disruptors enhance glucose-stimulated insulin secretion independent of the cortical actin cytoskeleton</dc:title>
  <dc:creator>Polino, Alexander</dc:creator>
  <cp:lastModifiedBy>Alex Polino</cp:lastModifiedBy>
  <cp:revision>72</cp:revision>
  <cp:lastPrinted>2023-05-08T17:15:49Z</cp:lastPrinted>
  <dcterms:created xsi:type="dcterms:W3CDTF">2023-05-02T18:54:07Z</dcterms:created>
  <dcterms:modified xsi:type="dcterms:W3CDTF">2023-07-15T14:06:58Z</dcterms:modified>
</cp:coreProperties>
</file>